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17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530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08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746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84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2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81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2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44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90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372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00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370A0-A9CF-471E-89E9-F1AA0FB16D27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A21DC-E95C-447E-8370-2F4EB2BB9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410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335122" y="233828"/>
            <a:ext cx="9956905" cy="4862037"/>
            <a:chOff x="519190" y="1243231"/>
            <a:chExt cx="9956905" cy="486203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316" y="1243231"/>
              <a:ext cx="3121152" cy="2340864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766872" y="3214763"/>
              <a:ext cx="8946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TN 1x</a:t>
              </a:r>
              <a:endParaRPr lang="en-US" dirty="0"/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4467" y="1243231"/>
              <a:ext cx="3124161" cy="2343121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6195517" y="3271860"/>
              <a:ext cx="8946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TN 4x</a:t>
              </a:r>
              <a:endParaRPr lang="en-US" dirty="0"/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91617" y="1243231"/>
              <a:ext cx="3121152" cy="2340864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9421173" y="3271860"/>
              <a:ext cx="10390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TN 10x</a:t>
              </a:r>
              <a:endParaRPr lang="en-US" dirty="0"/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73969" y="3696032"/>
              <a:ext cx="3121152" cy="2340864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9190" y="3696032"/>
              <a:ext cx="3121152" cy="2340864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91617" y="3702798"/>
              <a:ext cx="3121152" cy="2340864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2843984" y="5705349"/>
              <a:ext cx="8946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VE 1x</a:t>
              </a:r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405260" y="5735936"/>
              <a:ext cx="10708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VE 10x</a:t>
              </a:r>
              <a:endParaRPr 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35894" y="5708759"/>
              <a:ext cx="8946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VE 4x</a:t>
              </a:r>
              <a:endParaRPr lang="en-US" dirty="0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124691" y="5741719"/>
            <a:ext cx="10502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riginal raw microscopic images shown in Fig.1. CTN:</a:t>
            </a:r>
            <a:r>
              <a:rPr lang="en-US" dirty="0"/>
              <a:t>BVE-</a:t>
            </a:r>
            <a:r>
              <a:rPr lang="en-US" i="1" dirty="0"/>
              <a:t>Ctnnb1</a:t>
            </a:r>
            <a:r>
              <a:rPr lang="en-US" baseline="30000" dirty="0"/>
              <a:t>null</a:t>
            </a:r>
            <a:r>
              <a:rPr lang="en-US" dirty="0"/>
              <a:t> tumor </a:t>
            </a:r>
            <a:r>
              <a:rPr lang="en-US" dirty="0" smtClean="0"/>
              <a:t>cells; BVE:</a:t>
            </a:r>
            <a:r>
              <a:rPr lang="en-US" dirty="0"/>
              <a:t>BVE-</a:t>
            </a:r>
            <a:r>
              <a:rPr lang="en-US" i="1" dirty="0"/>
              <a:t>Ctnnb1</a:t>
            </a:r>
            <a:r>
              <a:rPr lang="en-US" baseline="30000" dirty="0"/>
              <a:t>wt</a:t>
            </a:r>
            <a:r>
              <a:rPr lang="en-US" dirty="0"/>
              <a:t> tumor cells</a:t>
            </a:r>
          </a:p>
        </p:txBody>
      </p:sp>
    </p:spTree>
    <p:extLst>
      <p:ext uri="{BB962C8B-B14F-4D97-AF65-F5344CB8AC3E}">
        <p14:creationId xmlns:p14="http://schemas.microsoft.com/office/powerpoint/2010/main" val="441110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7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, YUFEI</dc:creator>
  <cp:lastModifiedBy>SHI, YUFEI</cp:lastModifiedBy>
  <cp:revision>4</cp:revision>
  <dcterms:created xsi:type="dcterms:W3CDTF">2023-02-22T12:37:21Z</dcterms:created>
  <dcterms:modified xsi:type="dcterms:W3CDTF">2023-02-22T13:00:12Z</dcterms:modified>
</cp:coreProperties>
</file>